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30.wmf" ContentType="image/x-wmf"/>
  <Override PartName="/ppt/media/image28.wmf" ContentType="image/x-wmf"/>
  <Override PartName="/ppt/media/image10.wmf" ContentType="image/x-wmf"/>
  <Override PartName="/ppt/media/image29.wmf" ContentType="image/x-wmf"/>
  <Override PartName="/ppt/media/image5.wmf" ContentType="image/x-wmf"/>
  <Override PartName="/ppt/media/image35.wmf" ContentType="image/x-wmf"/>
  <Override PartName="/ppt/media/image11.wmf" ContentType="image/x-wmf"/>
  <Override PartName="/ppt/media/image6.wmf" ContentType="image/x-wmf"/>
  <Override PartName="/ppt/media/image36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media/image9.wmf" ContentType="image/x-wmf"/>
  <Override PartName="/ppt/media/image34.wmf" ContentType="image/x-wmf"/>
  <Override PartName="/ppt/media/image4.wmf" ContentType="image/x-wmf"/>
  <Override PartName="/ppt/media/image27.wmf" ContentType="image/x-wmf"/>
  <Override PartName="/ppt/media/image33.wmf" ContentType="image/x-wmf"/>
  <Override PartName="/ppt/media/image3.wmf" ContentType="image/x-wmf"/>
  <Override PartName="/ppt/media/image26.wmf" ContentType="image/x-wmf"/>
  <Override PartName="/ppt/media/image32.wmf" ContentType="image/x-wmf"/>
  <Override PartName="/ppt/media/image2.wmf" ContentType="image/x-wmf"/>
  <Override PartName="/ppt/media/image25.wmf" ContentType="image/x-wmf"/>
  <Override PartName="/ppt/media/image31.wmf" ContentType="image/x-wmf"/>
  <Override PartName="/ppt/media/image1.wmf" ContentType="image/x-wmf"/>
  <Override PartName="/ppt/media/image24.wmf" ContentType="image/x-wmf"/>
  <Override PartName="/ppt/media/image14.wmf" ContentType="image/x-wmf"/>
  <Override PartName="/ppt/media/image15.wmf" ContentType="image/x-wmf"/>
  <Override PartName="/ppt/media/image16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790F2-5566-465A-9CB0-CD10A80EAF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77752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4360" y="4130640"/>
            <a:ext cx="77752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AF5A9-D068-4BA3-B962-81B760F69F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4360" y="413064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A25D4-A296-495C-B0AF-4C3A8026DF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25034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440" y="1981080"/>
            <a:ext cx="25034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2520" y="1981080"/>
            <a:ext cx="25034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4360" y="4130640"/>
            <a:ext cx="25034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440" y="4130640"/>
            <a:ext cx="25034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2520" y="4130640"/>
            <a:ext cx="25034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9557B-4FE4-4AE8-AED1-71E340095A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4360" y="1981080"/>
            <a:ext cx="777528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F80A9-22AF-4532-AF95-45EB704FB9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77752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6C350-19B2-41F7-AD96-09836E8B16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379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A23A3-39BA-4804-8505-9ACD7BD6D9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6F6C81-868D-44DE-9E7D-A2193AF3E8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4360" y="609120"/>
            <a:ext cx="777528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0AF1F-C0EF-4D8B-BB9C-E360DDB241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4360" y="413064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35588-B5FD-4232-9CC6-CBD61A596E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379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D1485-C54E-4B00-93C2-7B3EA64F44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4360" y="198108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4360" y="4130640"/>
            <a:ext cx="77752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85BAD-AA5A-4D0F-A9F1-BDA5C1E34C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4360" y="609120"/>
            <a:ext cx="7775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4360" y="1981080"/>
            <a:ext cx="77752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4360" y="6248520"/>
            <a:ext cx="19065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65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3DA2B8-7FCD-4DA3-9096-164CE8C93D5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0.wmf"/><Relationship Id="rId2" Type="http://schemas.openxmlformats.org/officeDocument/2006/relationships/image" Target="../media/image31.wmf"/><Relationship Id="rId3" Type="http://schemas.openxmlformats.org/officeDocument/2006/relationships/image" Target="../media/image32.wmf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3.wmf"/><Relationship Id="rId2" Type="http://schemas.openxmlformats.org/officeDocument/2006/relationships/image" Target="../media/image34.wmf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5.wmf"/><Relationship Id="rId2" Type="http://schemas.openxmlformats.org/officeDocument/2006/relationships/image" Target="../media/image36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image" Target="../media/image5.wmf"/><Relationship Id="rId3" Type="http://schemas.openxmlformats.org/officeDocument/2006/relationships/image" Target="../media/image6.wmf"/><Relationship Id="rId4" Type="http://schemas.openxmlformats.org/officeDocument/2006/relationships/image" Target="../media/image7.wmf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image" Target="../media/image11.wmf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image" Target="../media/image13.wmf"/><Relationship Id="rId3" Type="http://schemas.openxmlformats.org/officeDocument/2006/relationships/image" Target="../media/image14.wmf"/><Relationship Id="rId4" Type="http://schemas.openxmlformats.org/officeDocument/2006/relationships/image" Target="../media/image15.wmf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image" Target="../media/image17.wmf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image" Target="../media/image19.wmf"/><Relationship Id="rId3" Type="http://schemas.openxmlformats.org/officeDocument/2006/relationships/image" Target="../media/image20.wmf"/><Relationship Id="rId4" Type="http://schemas.openxmlformats.org/officeDocument/2006/relationships/image" Target="../media/image21.wmf"/><Relationship Id="rId5" Type="http://schemas.openxmlformats.org/officeDocument/2006/relationships/image" Target="../media/image22.wmf"/><Relationship Id="rId6" Type="http://schemas.openxmlformats.org/officeDocument/2006/relationships/image" Target="../media/image23.wmf"/><Relationship Id="rId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4.wmf"/><Relationship Id="rId2" Type="http://schemas.openxmlformats.org/officeDocument/2006/relationships/image" Target="../media/image25.wmf"/><Relationship Id="rId3" Type="http://schemas.openxmlformats.org/officeDocument/2006/relationships/image" Target="../media/image26.wmf"/><Relationship Id="rId4" Type="http://schemas.openxmlformats.org/officeDocument/2006/relationships/image" Target="../media/image27.wmf"/><Relationship Id="rId5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8.wmf"/><Relationship Id="rId2" Type="http://schemas.openxmlformats.org/officeDocument/2006/relationships/image" Target="../media/image29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39640" y="549000"/>
            <a:ext cx="8229600" cy="18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000" spc="-1" strike="noStrike">
                <a:solidFill>
                  <a:srgbClr val="000000"/>
                </a:solidFill>
                <a:latin typeface="Times New Roman"/>
              </a:rPr>
              <a:t>Relevant KEGG pathways</a:t>
            </a:r>
            <a:br>
              <a:rPr sz="4000"/>
            </a:br>
            <a:r>
              <a:rPr b="0" lang="nl-NL" sz="4000" spc="-1" strike="noStrike">
                <a:solidFill>
                  <a:srgbClr val="000000"/>
                </a:solidFill>
                <a:latin typeface="Times New Roman"/>
              </a:rPr>
              <a:t>Additional file 3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492120" y="2565000"/>
            <a:ext cx="8229600" cy="12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Te Pas et al.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737720" y="4313160"/>
            <a:ext cx="63939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The file shows more KEGG pathways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as found by the PERL script search of the databas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Including gene expression profile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" descr=""/>
          <p:cNvPicPr/>
          <p:nvPr/>
        </p:nvPicPr>
        <p:blipFill>
          <a:blip r:embed="rId1"/>
          <a:stretch/>
        </p:blipFill>
        <p:spPr>
          <a:xfrm>
            <a:off x="380880" y="228600"/>
            <a:ext cx="4876920" cy="288756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2"/>
          <a:stretch/>
        </p:blipFill>
        <p:spPr>
          <a:xfrm>
            <a:off x="5435640" y="836640"/>
            <a:ext cx="3591000" cy="2274840"/>
          </a:xfrm>
          <a:prstGeom prst="rect">
            <a:avLst/>
          </a:prstGeom>
          <a:ln w="0">
            <a:noFill/>
          </a:ln>
        </p:spPr>
      </p:pic>
      <p:pic>
        <p:nvPicPr>
          <p:cNvPr id="80" name="" descr=""/>
          <p:cNvPicPr/>
          <p:nvPr/>
        </p:nvPicPr>
        <p:blipFill>
          <a:blip r:embed="rId3"/>
          <a:stretch/>
        </p:blipFill>
        <p:spPr>
          <a:xfrm>
            <a:off x="2268360" y="3429000"/>
            <a:ext cx="4680000" cy="3021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304920" y="304920"/>
            <a:ext cx="6781680" cy="345276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2"/>
          <a:stretch/>
        </p:blipFill>
        <p:spPr>
          <a:xfrm>
            <a:off x="2771640" y="3973680"/>
            <a:ext cx="4105440" cy="2600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304920" y="228600"/>
            <a:ext cx="5105160" cy="334656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2"/>
          <a:stretch/>
        </p:blipFill>
        <p:spPr>
          <a:xfrm>
            <a:off x="3924360" y="3433680"/>
            <a:ext cx="4957560" cy="3140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619200" y="533520"/>
            <a:ext cx="3533760" cy="534348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252720" y="476280"/>
            <a:ext cx="449820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     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     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6" name="" descr=""/>
          <p:cNvPicPr/>
          <p:nvPr/>
        </p:nvPicPr>
        <p:blipFill>
          <a:blip r:embed="rId2"/>
          <a:stretch/>
        </p:blipFill>
        <p:spPr>
          <a:xfrm>
            <a:off x="4716360" y="549360"/>
            <a:ext cx="4094280" cy="279720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3"/>
          <a:stretch/>
        </p:blipFill>
        <p:spPr>
          <a:xfrm>
            <a:off x="4716360" y="3419640"/>
            <a:ext cx="4054680" cy="2514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533520" y="457200"/>
            <a:ext cx="4543200" cy="300528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181080" y="549360"/>
            <a:ext cx="5412600" cy="375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     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C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         D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4932360" y="3645000"/>
            <a:ext cx="3846600" cy="247320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539640" y="3670200"/>
            <a:ext cx="3816360" cy="243684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4"/>
          <a:stretch/>
        </p:blipFill>
        <p:spPr>
          <a:xfrm>
            <a:off x="5508720" y="404640"/>
            <a:ext cx="3311280" cy="2900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533520" y="533520"/>
            <a:ext cx="3047760" cy="388620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4067280" y="549360"/>
            <a:ext cx="4452840" cy="298908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3"/>
          <a:stretch/>
        </p:blipFill>
        <p:spPr>
          <a:xfrm>
            <a:off x="4067280" y="3652920"/>
            <a:ext cx="4384440" cy="281304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4"/>
          <a:stretch/>
        </p:blipFill>
        <p:spPr>
          <a:xfrm>
            <a:off x="539640" y="4506840"/>
            <a:ext cx="3024360" cy="194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380880" y="380880"/>
            <a:ext cx="4419720" cy="328608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2"/>
          <a:stretch/>
        </p:blipFill>
        <p:spPr>
          <a:xfrm>
            <a:off x="5076720" y="189000"/>
            <a:ext cx="3184560" cy="388764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3"/>
          <a:stretch/>
        </p:blipFill>
        <p:spPr>
          <a:xfrm>
            <a:off x="4500720" y="4076640"/>
            <a:ext cx="3733560" cy="240840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4"/>
          <a:stretch/>
        </p:blipFill>
        <p:spPr>
          <a:xfrm>
            <a:off x="539640" y="4122720"/>
            <a:ext cx="3672000" cy="2367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612720" y="297000"/>
            <a:ext cx="5399280" cy="274932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250920" y="33336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253080" y="333360"/>
            <a:ext cx="40032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4" name="" descr=""/>
          <p:cNvPicPr/>
          <p:nvPr/>
        </p:nvPicPr>
        <p:blipFill>
          <a:blip r:embed="rId2"/>
          <a:stretch/>
        </p:blipFill>
        <p:spPr>
          <a:xfrm>
            <a:off x="539640" y="3213000"/>
            <a:ext cx="5534280" cy="3353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304920" y="304920"/>
            <a:ext cx="4190760" cy="332712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"/>
          <a:stretch/>
        </p:blipFill>
        <p:spPr>
          <a:xfrm>
            <a:off x="4932360" y="333360"/>
            <a:ext cx="4021200" cy="397188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3"/>
          <a:stretch/>
        </p:blipFill>
        <p:spPr>
          <a:xfrm>
            <a:off x="3635280" y="260280"/>
            <a:ext cx="2087640" cy="134928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4"/>
          <a:stretch/>
        </p:blipFill>
        <p:spPr>
          <a:xfrm>
            <a:off x="324000" y="4035600"/>
            <a:ext cx="3311280" cy="213516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5"/>
          <a:stretch/>
        </p:blipFill>
        <p:spPr>
          <a:xfrm>
            <a:off x="2987640" y="4437000"/>
            <a:ext cx="3168720" cy="204156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6"/>
          <a:stretch/>
        </p:blipFill>
        <p:spPr>
          <a:xfrm>
            <a:off x="5508720" y="4581360"/>
            <a:ext cx="3240000" cy="2086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380880" y="380880"/>
            <a:ext cx="4343400" cy="336564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4859280" y="404640"/>
            <a:ext cx="3951360" cy="340704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3"/>
          <a:stretch/>
        </p:blipFill>
        <p:spPr>
          <a:xfrm>
            <a:off x="468360" y="3919680"/>
            <a:ext cx="4032360" cy="2597040"/>
          </a:xfrm>
          <a:prstGeom prst="rect">
            <a:avLst/>
          </a:prstGeom>
          <a:ln w="0">
            <a:noFill/>
          </a:ln>
        </p:spPr>
      </p:pic>
      <p:pic>
        <p:nvPicPr>
          <p:cNvPr id="74" name="" descr=""/>
          <p:cNvPicPr/>
          <p:nvPr/>
        </p:nvPicPr>
        <p:blipFill>
          <a:blip r:embed="rId4"/>
          <a:stretch/>
        </p:blipFill>
        <p:spPr>
          <a:xfrm>
            <a:off x="4788000" y="3909960"/>
            <a:ext cx="4022640" cy="2598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" descr=""/>
          <p:cNvPicPr/>
          <p:nvPr/>
        </p:nvPicPr>
        <p:blipFill>
          <a:blip r:embed="rId1"/>
          <a:stretch/>
        </p:blipFill>
        <p:spPr>
          <a:xfrm>
            <a:off x="900000" y="237960"/>
            <a:ext cx="4680000" cy="319248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>
            <a:off x="397440" y="260280"/>
            <a:ext cx="400320" cy="375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7" name="" descr=""/>
          <p:cNvPicPr/>
          <p:nvPr/>
        </p:nvPicPr>
        <p:blipFill>
          <a:blip r:embed="rId2"/>
          <a:stretch/>
        </p:blipFill>
        <p:spPr>
          <a:xfrm>
            <a:off x="900000" y="3645000"/>
            <a:ext cx="4751640" cy="2886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6-06T12:24:46Z</dcterms:created>
  <dc:creator>AIV</dc:creator>
  <dc:description/>
  <dc:language>en-US</dc:language>
  <cp:lastModifiedBy>morven.mellan</cp:lastModifiedBy>
  <dcterms:modified xsi:type="dcterms:W3CDTF">2007-07-02T15:00:37Z</dcterms:modified>
  <cp:revision>30</cp:revision>
  <dc:subject/>
  <dc:title>PowerPoint-presentatie</dc:title>
</cp:coreProperties>
</file>